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7" r:id="rId2"/>
    <p:sldId id="2672" r:id="rId3"/>
    <p:sldId id="2676" r:id="rId4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643" y="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3510626-9B3F-48BF-9744-960E478387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8AA2699C-553F-41D9-9CDD-8D92347A72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FAF8739-9207-4C6E-9445-450824435E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FA915-E01B-4A42-A74E-EEA11244D83F}" type="datetimeFigureOut">
              <a:rPr lang="es-ES" smtClean="0"/>
              <a:t>24/07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ED69AAF-55ED-4654-9524-C25B6B0EB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2E45074-8BC3-4050-AA13-B033C5C9F4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B4583-9D40-404D-A9EA-4F1DB10E0B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205371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09E7F26-C596-4F59-8410-BAB142D59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3CD6FF54-549B-43BF-BCB1-C1E143D26B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A0186AE-BB1D-4092-AC2E-C134A25336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FA915-E01B-4A42-A74E-EEA11244D83F}" type="datetimeFigureOut">
              <a:rPr lang="es-ES" smtClean="0"/>
              <a:t>24/07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AEE506E-AC7F-4987-AE92-DB5E191B1D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DBAF95D-5B7C-44B8-B572-1CA7A5BB6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B4583-9D40-404D-A9EA-4F1DB10E0B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43306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72671A61-6EC7-4FFE-B48E-47133AC4C0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D68173FD-B5A2-430D-A073-21B090FB25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47BE602-39AF-46DB-B640-8956865B1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FA915-E01B-4A42-A74E-EEA11244D83F}" type="datetimeFigureOut">
              <a:rPr lang="es-ES" smtClean="0"/>
              <a:t>24/07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8FB5FB4-99F3-4DEE-818C-752E2975C9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FA90EB7-DE0F-4F11-9E12-374001A728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B4583-9D40-404D-A9EA-4F1DB10E0B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33978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589CFB4-D038-4106-B65F-1F6BDDC397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B1167D5-3710-4607-AC84-16E398A588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35149A2-965D-47D5-879C-9CBDB6A791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FA915-E01B-4A42-A74E-EEA11244D83F}" type="datetimeFigureOut">
              <a:rPr lang="es-ES" smtClean="0"/>
              <a:t>24/07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A9E0D85-97B2-4DD7-A96D-58EC1FBCB3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8C9B4D7-398E-4E35-97C8-2C7DE77BAE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B4583-9D40-404D-A9EA-4F1DB10E0B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69607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8B6A9E-F4D1-4526-B273-BCA10301F0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F039511-C3C9-4E14-BC9B-4F6D3BC765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B0D65F5-B787-4AB4-B028-A3AF6E4F1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FA915-E01B-4A42-A74E-EEA11244D83F}" type="datetimeFigureOut">
              <a:rPr lang="es-ES" smtClean="0"/>
              <a:t>24/07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AE5CA34-3278-4329-B695-062634D772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C80B0B2-B489-4EDF-B907-3F4139070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B4583-9D40-404D-A9EA-4F1DB10E0B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4786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0D5ABA7-28E5-4FC3-96F3-3E46ADAFEF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DE24712-3D0C-4DB6-AE49-44B5C3DA60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DB070CD-A7F9-444A-AE46-7FE0003FFD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339D01B-77D3-47DC-98DA-1FB5C19602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FA915-E01B-4A42-A74E-EEA11244D83F}" type="datetimeFigureOut">
              <a:rPr lang="es-ES" smtClean="0"/>
              <a:t>24/07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27774E9-F17B-476D-8662-9EE4619B1B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4BF4970-4978-4ABD-9DB1-68A85029F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B4583-9D40-404D-A9EA-4F1DB10E0B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17317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5833873-2012-4A89-86B9-A6F316E117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81331B6-A602-4BFB-828E-37B2BD17BB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6FBC3F6-6777-4A85-A297-88F5BD4DA4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598A7BE4-1A2E-4238-B213-1B016C8D94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36A044A3-5E7D-4932-92A8-D788BD2600A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AC9E44B9-E4B4-4B73-B13E-E67538229F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FA915-E01B-4A42-A74E-EEA11244D83F}" type="datetimeFigureOut">
              <a:rPr lang="es-ES" smtClean="0"/>
              <a:t>24/07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05F2CD98-3592-4A95-9B06-04EE3193C5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11CE43D-A5EB-4EAD-BD21-6B5FEBE1B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B4583-9D40-404D-A9EA-4F1DB10E0B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55439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94F6976-44DC-43B6-B08C-9445F3AA53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602A6BDA-56C0-4760-8939-D663F0DFB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FA915-E01B-4A42-A74E-EEA11244D83F}" type="datetimeFigureOut">
              <a:rPr lang="es-ES" smtClean="0"/>
              <a:t>24/07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5FCC78BB-EF62-47EB-A6A9-0D1A22C2B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6761CA66-4B42-458C-A4A8-514B7D872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B4583-9D40-404D-A9EA-4F1DB10E0B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9204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1A73499C-DBA9-4795-B1FD-FF210CE05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FA915-E01B-4A42-A74E-EEA11244D83F}" type="datetimeFigureOut">
              <a:rPr lang="es-ES" smtClean="0"/>
              <a:t>24/07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3E10EA0-89FB-4EBC-9E1A-0F21E46B8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BAD8F07-6E68-47C6-836F-6DEF224E9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B4583-9D40-404D-A9EA-4F1DB10E0B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7655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6CA015C-F4CA-446F-B69F-ED4AAAE116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F53B179-F390-469A-9AF4-B5F5284186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D510C50-2AA9-483D-9FBC-7913709BD3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80A753C-9960-49C6-98BC-91F0114606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FA915-E01B-4A42-A74E-EEA11244D83F}" type="datetimeFigureOut">
              <a:rPr lang="es-ES" smtClean="0"/>
              <a:t>24/07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EB5AB88-4612-4609-92E5-50472F2FF6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99F4B23-4277-4AD3-BB47-A1E51CD6E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B4583-9D40-404D-A9EA-4F1DB10E0B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536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2D7EDB2-C56D-4B0F-86BD-9B4ED1AEF1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AB09A113-8741-4B23-9C73-159D748117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8E70163-4AC2-4FD8-842A-6D0CFCA928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122AD92-E1BC-4ABC-8929-DCCCCADB0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FA915-E01B-4A42-A74E-EEA11244D83F}" type="datetimeFigureOut">
              <a:rPr lang="es-ES" smtClean="0"/>
              <a:t>24/07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B121DAB-F9E5-4DA0-B776-8C1043EC3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CBECD27-A272-4A7B-8F09-E76B7E5EDC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B4583-9D40-404D-A9EA-4F1DB10E0B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41327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57ECBDB1-BD8F-4E1F-AE85-ECA119F35B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76F6557-3EAE-4BC2-94E9-49D0D2087A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E2B03FC-1C88-4905-B3B4-6C4BAFE068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CFA915-E01B-4A42-A74E-EEA11244D83F}" type="datetimeFigureOut">
              <a:rPr lang="es-ES" smtClean="0"/>
              <a:t>24/07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F7BFECB-8C16-434D-B1FA-F2E0C594F6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D7512FD-EDD5-43BE-A58D-0702CEBF7C4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EB4583-9D40-404D-A9EA-4F1DB10E0B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8053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ángulo 5">
            <a:extLst>
              <a:ext uri="{FF2B5EF4-FFF2-40B4-BE49-F238E27FC236}">
                <a16:creationId xmlns:a16="http://schemas.microsoft.com/office/drawing/2014/main" id="{D37C1FAF-F16A-4623-9263-8D7AF7EA28CA}"/>
              </a:ext>
            </a:extLst>
          </p:cNvPr>
          <p:cNvSpPr/>
          <p:nvPr/>
        </p:nvSpPr>
        <p:spPr>
          <a:xfrm>
            <a:off x="876301" y="5167438"/>
            <a:ext cx="1131569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Uncropped version of Figure 2c.</a:t>
            </a:r>
            <a:r>
              <a:rPr lang="en-US" sz="1200" dirty="0"/>
              <a:t> The samples have been highlighted with a box in the uncropped image to facilitate their identification.</a:t>
            </a:r>
            <a:endParaRPr lang="es-ES" sz="1200" dirty="0"/>
          </a:p>
        </p:txBody>
      </p:sp>
      <p:pic>
        <p:nvPicPr>
          <p:cNvPr id="11" name="Picture 20" descr="20070530_10 viejo">
            <a:extLst>
              <a:ext uri="{FF2B5EF4-FFF2-40B4-BE49-F238E27FC236}">
                <a16:creationId xmlns:a16="http://schemas.microsoft.com/office/drawing/2014/main" id="{EFA6D86F-236E-43A6-AC06-7DB0BFB2FD8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64" t="7083" r="73895" b="63892"/>
          <a:stretch/>
        </p:blipFill>
        <p:spPr bwMode="auto">
          <a:xfrm rot="16200000" flipH="1">
            <a:off x="3842283" y="1327968"/>
            <a:ext cx="200723" cy="7703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20" descr="20070530_10 viejo">
            <a:extLst>
              <a:ext uri="{FF2B5EF4-FFF2-40B4-BE49-F238E27FC236}">
                <a16:creationId xmlns:a16="http://schemas.microsoft.com/office/drawing/2014/main" id="{5D44463C-7A7F-4B2A-9AFF-E0057588177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64" t="67762" r="73671" b="15505"/>
          <a:stretch/>
        </p:blipFill>
        <p:spPr bwMode="auto">
          <a:xfrm rot="16200000" flipH="1">
            <a:off x="3641024" y="1948401"/>
            <a:ext cx="209643" cy="4441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6" descr="20070530_10 viejo">
            <a:extLst>
              <a:ext uri="{FF2B5EF4-FFF2-40B4-BE49-F238E27FC236}">
                <a16:creationId xmlns:a16="http://schemas.microsoft.com/office/drawing/2014/main" id="{9BA983A5-63E4-46CD-B597-06B4E3BCD8C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711" t="22312" r="25130" b="61601"/>
          <a:stretch/>
        </p:blipFill>
        <p:spPr bwMode="auto">
          <a:xfrm rot="16200000" flipH="1">
            <a:off x="4045289" y="1954846"/>
            <a:ext cx="205419" cy="427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6" descr="20070530_10 viejo">
            <a:extLst>
              <a:ext uri="{FF2B5EF4-FFF2-40B4-BE49-F238E27FC236}">
                <a16:creationId xmlns:a16="http://schemas.microsoft.com/office/drawing/2014/main" id="{35DBCC8A-A056-40D5-8E72-D63DC189609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606" t="38563" r="24858" b="30268"/>
          <a:stretch/>
        </p:blipFill>
        <p:spPr bwMode="auto">
          <a:xfrm rot="16200000" flipH="1">
            <a:off x="3852332" y="2213372"/>
            <a:ext cx="180625" cy="8273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CuadroTexto 15">
            <a:extLst>
              <a:ext uri="{FF2B5EF4-FFF2-40B4-BE49-F238E27FC236}">
                <a16:creationId xmlns:a16="http://schemas.microsoft.com/office/drawing/2014/main" id="{6A97911E-646A-4DB6-A6CF-DB0C3D28215A}"/>
              </a:ext>
            </a:extLst>
          </p:cNvPr>
          <p:cNvSpPr txBox="1"/>
          <p:nvPr/>
        </p:nvSpPr>
        <p:spPr>
          <a:xfrm>
            <a:off x="3587244" y="1351276"/>
            <a:ext cx="2873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A83B1053-B4CC-4C47-B948-D3CDB1D483BC}"/>
              </a:ext>
            </a:extLst>
          </p:cNvPr>
          <p:cNvSpPr txBox="1"/>
          <p:nvPr/>
        </p:nvSpPr>
        <p:spPr>
          <a:xfrm>
            <a:off x="1872391" y="1598383"/>
            <a:ext cx="14456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M15 (pREP4, pPAZ3)</a:t>
            </a:r>
            <a:endParaRPr lang="es-ES" sz="1050" dirty="0"/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9845EF52-C852-4D70-AE69-9B92C87BF2F6}"/>
              </a:ext>
            </a:extLst>
          </p:cNvPr>
          <p:cNvSpPr txBox="1"/>
          <p:nvPr/>
        </p:nvSpPr>
        <p:spPr>
          <a:xfrm>
            <a:off x="1872391" y="2077355"/>
            <a:ext cx="14456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M15 (pREP4, pQEFNGI)</a:t>
            </a:r>
            <a:endParaRPr lang="es-ES" sz="1050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9D053E2D-3540-4696-9535-C06FD4318917}"/>
              </a:ext>
            </a:extLst>
          </p:cNvPr>
          <p:cNvSpPr txBox="1"/>
          <p:nvPr/>
        </p:nvSpPr>
        <p:spPr>
          <a:xfrm>
            <a:off x="1872391" y="2504075"/>
            <a:ext cx="17417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M15 (pREP4, pQEYYWQLF)</a:t>
            </a:r>
            <a:endParaRPr lang="es-ES" sz="1050" dirty="0"/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299A63B2-2A5C-4A51-8E66-65C17A5DD987}"/>
              </a:ext>
            </a:extLst>
          </p:cNvPr>
          <p:cNvSpPr txBox="1"/>
          <p:nvPr/>
        </p:nvSpPr>
        <p:spPr>
          <a:xfrm>
            <a:off x="3972970" y="805903"/>
            <a:ext cx="101890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dirty="0"/>
              <a:t>C</a:t>
            </a:r>
          </a:p>
        </p:txBody>
      </p:sp>
      <p:sp>
        <p:nvSpPr>
          <p:cNvPr id="29" name="Rectángulo 28">
            <a:extLst>
              <a:ext uri="{FF2B5EF4-FFF2-40B4-BE49-F238E27FC236}">
                <a16:creationId xmlns:a16="http://schemas.microsoft.com/office/drawing/2014/main" id="{D42CE34E-C2DA-4596-A80E-C51018EE5C35}"/>
              </a:ext>
            </a:extLst>
          </p:cNvPr>
          <p:cNvSpPr/>
          <p:nvPr/>
        </p:nvSpPr>
        <p:spPr>
          <a:xfrm>
            <a:off x="1721805" y="631732"/>
            <a:ext cx="2832100" cy="29845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8" name="Picture 20" descr="20070530_10 viejo">
            <a:extLst>
              <a:ext uri="{FF2B5EF4-FFF2-40B4-BE49-F238E27FC236}">
                <a16:creationId xmlns:a16="http://schemas.microsoft.com/office/drawing/2014/main" id="{BBB5DD12-4EFB-4B19-9281-4876D6829CA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402" t="-25470" r="-220" b="-19012"/>
          <a:stretch/>
        </p:blipFill>
        <p:spPr bwMode="auto">
          <a:xfrm rot="16200000" flipH="1">
            <a:off x="5187821" y="578499"/>
            <a:ext cx="4245429" cy="38348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CuadroTexto 29">
            <a:extLst>
              <a:ext uri="{FF2B5EF4-FFF2-40B4-BE49-F238E27FC236}">
                <a16:creationId xmlns:a16="http://schemas.microsoft.com/office/drawing/2014/main" id="{9BA68961-ED75-451A-A7F9-38721F44F4FB}"/>
              </a:ext>
            </a:extLst>
          </p:cNvPr>
          <p:cNvSpPr txBox="1"/>
          <p:nvPr/>
        </p:nvSpPr>
        <p:spPr>
          <a:xfrm>
            <a:off x="6199816" y="1146002"/>
            <a:ext cx="2873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C0CCA407-3EA2-46D9-9186-A5AD835C1534}"/>
              </a:ext>
            </a:extLst>
          </p:cNvPr>
          <p:cNvSpPr txBox="1"/>
          <p:nvPr/>
        </p:nvSpPr>
        <p:spPr>
          <a:xfrm>
            <a:off x="6609119" y="1146002"/>
            <a:ext cx="2873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2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C63C4783-5FDC-41A2-9AF3-A6D568126ADB}"/>
              </a:ext>
            </a:extLst>
          </p:cNvPr>
          <p:cNvSpPr txBox="1"/>
          <p:nvPr/>
        </p:nvSpPr>
        <p:spPr>
          <a:xfrm>
            <a:off x="4995611" y="1159843"/>
            <a:ext cx="14456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M15 (pREP4, pPAZ3)</a:t>
            </a:r>
            <a:endParaRPr lang="es-ES" sz="1050" dirty="0"/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FB8AB6FC-9CDE-4B08-B39F-9D9F2A584357}"/>
              </a:ext>
            </a:extLst>
          </p:cNvPr>
          <p:cNvSpPr txBox="1"/>
          <p:nvPr/>
        </p:nvSpPr>
        <p:spPr>
          <a:xfrm>
            <a:off x="7907318" y="1155333"/>
            <a:ext cx="2873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D70986F2-37F3-4340-8AAA-656D06250D82}"/>
              </a:ext>
            </a:extLst>
          </p:cNvPr>
          <p:cNvSpPr txBox="1"/>
          <p:nvPr/>
        </p:nvSpPr>
        <p:spPr>
          <a:xfrm>
            <a:off x="8179885" y="1125632"/>
            <a:ext cx="14456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M15 (pREP4, pQEFNGI)</a:t>
            </a:r>
            <a:endParaRPr lang="es-ES" sz="1050" dirty="0"/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266230E3-E58A-4A62-9064-280F05E83BBA}"/>
              </a:ext>
            </a:extLst>
          </p:cNvPr>
          <p:cNvSpPr txBox="1"/>
          <p:nvPr/>
        </p:nvSpPr>
        <p:spPr>
          <a:xfrm>
            <a:off x="6739747" y="3068108"/>
            <a:ext cx="2873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2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DF692C71-8A61-499A-B70C-6C5C88CEB3A5}"/>
              </a:ext>
            </a:extLst>
          </p:cNvPr>
          <p:cNvSpPr txBox="1"/>
          <p:nvPr/>
        </p:nvSpPr>
        <p:spPr>
          <a:xfrm>
            <a:off x="5268734" y="3029077"/>
            <a:ext cx="144562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M15 (pREP4, pQEFNGI)</a:t>
            </a:r>
            <a:endParaRPr lang="es-ES" sz="1050" dirty="0"/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2C546402-2D89-442A-A2E3-C80BFBBF5C7D}"/>
              </a:ext>
            </a:extLst>
          </p:cNvPr>
          <p:cNvSpPr txBox="1"/>
          <p:nvPr/>
        </p:nvSpPr>
        <p:spPr>
          <a:xfrm>
            <a:off x="3968555" y="1351276"/>
            <a:ext cx="2873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2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5B93ED9F-0BA4-4EC9-8D37-483123740E17}"/>
              </a:ext>
            </a:extLst>
          </p:cNvPr>
          <p:cNvSpPr txBox="1"/>
          <p:nvPr/>
        </p:nvSpPr>
        <p:spPr>
          <a:xfrm>
            <a:off x="7200171" y="4052956"/>
            <a:ext cx="174171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M15 (pREP4, pQEYYWQLF)</a:t>
            </a:r>
            <a:endParaRPr lang="es-ES" sz="1050" dirty="0"/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52257356-1706-4C12-A35C-5D06AE7C6544}"/>
              </a:ext>
            </a:extLst>
          </p:cNvPr>
          <p:cNvSpPr txBox="1"/>
          <p:nvPr/>
        </p:nvSpPr>
        <p:spPr>
          <a:xfrm>
            <a:off x="7188861" y="3777235"/>
            <a:ext cx="2873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1</a:t>
            </a: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C9514052-7F0F-490C-97E0-3636A24EA1C2}"/>
              </a:ext>
            </a:extLst>
          </p:cNvPr>
          <p:cNvSpPr txBox="1"/>
          <p:nvPr/>
        </p:nvSpPr>
        <p:spPr>
          <a:xfrm>
            <a:off x="7570172" y="3777235"/>
            <a:ext cx="2873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/>
              <a:t>2</a:t>
            </a:r>
          </a:p>
        </p:txBody>
      </p:sp>
      <p:sp>
        <p:nvSpPr>
          <p:cNvPr id="12" name="Rectángulo 11">
            <a:extLst>
              <a:ext uri="{FF2B5EF4-FFF2-40B4-BE49-F238E27FC236}">
                <a16:creationId xmlns:a16="http://schemas.microsoft.com/office/drawing/2014/main" id="{4E0B02C0-CA79-4EBB-8001-8E51D1DBE658}"/>
              </a:ext>
            </a:extLst>
          </p:cNvPr>
          <p:cNvSpPr/>
          <p:nvPr/>
        </p:nvSpPr>
        <p:spPr>
          <a:xfrm>
            <a:off x="4935894" y="1101012"/>
            <a:ext cx="2080726" cy="335902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0" name="Rectángulo 39">
            <a:extLst>
              <a:ext uri="{FF2B5EF4-FFF2-40B4-BE49-F238E27FC236}">
                <a16:creationId xmlns:a16="http://schemas.microsoft.com/office/drawing/2014/main" id="{A213AA26-745B-4A98-A8ED-5D833A3A8945}"/>
              </a:ext>
            </a:extLst>
          </p:cNvPr>
          <p:cNvSpPr/>
          <p:nvPr/>
        </p:nvSpPr>
        <p:spPr>
          <a:xfrm>
            <a:off x="7903029" y="1110343"/>
            <a:ext cx="2080726" cy="335902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1" name="Rectángulo 40">
            <a:extLst>
              <a:ext uri="{FF2B5EF4-FFF2-40B4-BE49-F238E27FC236}">
                <a16:creationId xmlns:a16="http://schemas.microsoft.com/office/drawing/2014/main" id="{2F1550EF-9054-41D3-8CDB-704D2FA28F02}"/>
              </a:ext>
            </a:extLst>
          </p:cNvPr>
          <p:cNvSpPr/>
          <p:nvPr/>
        </p:nvSpPr>
        <p:spPr>
          <a:xfrm>
            <a:off x="5055637" y="2957804"/>
            <a:ext cx="2080726" cy="335902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4" name="Rectángulo 43">
            <a:extLst>
              <a:ext uri="{FF2B5EF4-FFF2-40B4-BE49-F238E27FC236}">
                <a16:creationId xmlns:a16="http://schemas.microsoft.com/office/drawing/2014/main" id="{C3C7F430-B62C-4744-8480-3A1EE89B10DD}"/>
              </a:ext>
            </a:extLst>
          </p:cNvPr>
          <p:cNvSpPr/>
          <p:nvPr/>
        </p:nvSpPr>
        <p:spPr>
          <a:xfrm>
            <a:off x="7089711" y="3788228"/>
            <a:ext cx="2080726" cy="569167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7696962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5" descr="321021008">
            <a:extLst>
              <a:ext uri="{FF2B5EF4-FFF2-40B4-BE49-F238E27FC236}">
                <a16:creationId xmlns:a16="http://schemas.microsoft.com/office/drawing/2014/main" id="{5FF674C6-6AA1-4E2E-BA2E-CE04AF0793F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lum brigh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493" t="-12719" r="-19571" b="-8218"/>
          <a:stretch/>
        </p:blipFill>
        <p:spPr bwMode="auto">
          <a:xfrm>
            <a:off x="0" y="2855167"/>
            <a:ext cx="5178490" cy="32097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Cuadro de texto 3">
            <a:extLst>
              <a:ext uri="{FF2B5EF4-FFF2-40B4-BE49-F238E27FC236}">
                <a16:creationId xmlns:a16="http://schemas.microsoft.com/office/drawing/2014/main" id="{A64343D4-0AA2-4FB8-9C2B-D779530FF0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2790" y="6055567"/>
            <a:ext cx="11163300" cy="47490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/>
              <a:t>Uncropped version of Figure 4c.</a:t>
            </a:r>
            <a:r>
              <a:rPr lang="en-US" sz="1200" dirty="0"/>
              <a:t> Each gel is labeled with the corresponding sample name for clarity.</a:t>
            </a:r>
            <a:endParaRPr lang="es-ES" sz="1200" dirty="0">
              <a:effectLst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  <p:pic>
        <p:nvPicPr>
          <p:cNvPr id="18" name="Picture 4" descr="pPAZ1021008">
            <a:extLst>
              <a:ext uri="{FF2B5EF4-FFF2-40B4-BE49-F238E27FC236}">
                <a16:creationId xmlns:a16="http://schemas.microsoft.com/office/drawing/2014/main" id="{A42DF028-9AA4-4A65-AD0B-9C5B99FC385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lum bright="6000" contrast="-1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172" t="29797" r="21501" b="65282"/>
          <a:stretch>
            <a:fillRect/>
          </a:stretch>
        </p:blipFill>
        <p:spPr bwMode="auto">
          <a:xfrm>
            <a:off x="808524" y="997242"/>
            <a:ext cx="1800225" cy="1428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5" descr="321021008">
            <a:extLst>
              <a:ext uri="{FF2B5EF4-FFF2-40B4-BE49-F238E27FC236}">
                <a16:creationId xmlns:a16="http://schemas.microsoft.com/office/drawing/2014/main" id="{53CAB687-C1D4-4BE9-8D02-85E49EBF165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lum brigh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89" t="46112" r="19896" b="48445"/>
          <a:stretch>
            <a:fillRect/>
          </a:stretch>
        </p:blipFill>
        <p:spPr bwMode="auto">
          <a:xfrm>
            <a:off x="808524" y="1356016"/>
            <a:ext cx="1800225" cy="1444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6" descr="881021008">
            <a:extLst>
              <a:ext uri="{FF2B5EF4-FFF2-40B4-BE49-F238E27FC236}">
                <a16:creationId xmlns:a16="http://schemas.microsoft.com/office/drawing/2014/main" id="{A75901D5-1BD3-4621-BE1B-28FB5E40325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lum brigh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63" t="43481" r="18620" b="48386"/>
          <a:stretch>
            <a:fillRect/>
          </a:stretch>
        </p:blipFill>
        <p:spPr bwMode="auto">
          <a:xfrm>
            <a:off x="808524" y="1789403"/>
            <a:ext cx="1800225" cy="215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 Box 7">
            <a:extLst>
              <a:ext uri="{FF2B5EF4-FFF2-40B4-BE49-F238E27FC236}">
                <a16:creationId xmlns:a16="http://schemas.microsoft.com/office/drawing/2014/main" id="{BAF546C9-295C-464D-885A-49B70192B7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3210" y="924217"/>
            <a:ext cx="171527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1200" dirty="0"/>
              <a:t>DH5</a:t>
            </a:r>
            <a:r>
              <a:rPr lang="es-ES" altLang="es-ES" sz="1200" dirty="0">
                <a:latin typeface="Symbol" panose="05050102010706020507" pitchFamily="18" charset="2"/>
              </a:rPr>
              <a:t>a</a:t>
            </a:r>
            <a:r>
              <a:rPr lang="es-ES" altLang="es-ES" sz="1200" dirty="0"/>
              <a:t> (pPAZ1)- </a:t>
            </a:r>
            <a:r>
              <a:rPr lang="es-ES" altLang="es-ES" sz="1200" dirty="0" err="1"/>
              <a:t>PhaZKT</a:t>
            </a:r>
            <a:endParaRPr lang="es-ES" altLang="es-ES" sz="1200" dirty="0"/>
          </a:p>
        </p:txBody>
      </p:sp>
      <p:sp>
        <p:nvSpPr>
          <p:cNvPr id="23" name="Text Box 9">
            <a:extLst>
              <a:ext uri="{FF2B5EF4-FFF2-40B4-BE49-F238E27FC236}">
                <a16:creationId xmlns:a16="http://schemas.microsoft.com/office/drawing/2014/main" id="{1056D546-37D7-4220-B460-50F1787168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53210" y="1730667"/>
            <a:ext cx="184589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1200" dirty="0"/>
              <a:t>DH10B (pUC88)-  G286R</a:t>
            </a:r>
          </a:p>
        </p:txBody>
      </p:sp>
      <p:pic>
        <p:nvPicPr>
          <p:cNvPr id="25" name="Picture 15" descr="pPAZ1021008">
            <a:extLst>
              <a:ext uri="{FF2B5EF4-FFF2-40B4-BE49-F238E27FC236}">
                <a16:creationId xmlns:a16="http://schemas.microsoft.com/office/drawing/2014/main" id="{2E28044A-2E2A-42D2-81AA-B3CBE4409CC0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lum bright="6000" contrast="-1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708" t="29837" r="42947" b="65236"/>
          <a:stretch>
            <a:fillRect/>
          </a:stretch>
        </p:blipFill>
        <p:spPr bwMode="auto">
          <a:xfrm>
            <a:off x="1961048" y="997242"/>
            <a:ext cx="173038" cy="115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" name="Rectángulo 31">
            <a:extLst>
              <a:ext uri="{FF2B5EF4-FFF2-40B4-BE49-F238E27FC236}">
                <a16:creationId xmlns:a16="http://schemas.microsoft.com/office/drawing/2014/main" id="{AA640A85-8477-4427-B286-8DF168C5F12C}"/>
              </a:ext>
            </a:extLst>
          </p:cNvPr>
          <p:cNvSpPr/>
          <p:nvPr/>
        </p:nvSpPr>
        <p:spPr>
          <a:xfrm>
            <a:off x="484673" y="176503"/>
            <a:ext cx="4191000" cy="20828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/>
              <a:t>c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FE5459D2-396E-4B72-BA5E-0BC487546C0F}"/>
              </a:ext>
            </a:extLst>
          </p:cNvPr>
          <p:cNvSpPr txBox="1"/>
          <p:nvPr/>
        </p:nvSpPr>
        <p:spPr>
          <a:xfrm>
            <a:off x="620382" y="283909"/>
            <a:ext cx="44413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ES" dirty="0"/>
              <a:t>C</a:t>
            </a:r>
          </a:p>
        </p:txBody>
      </p:sp>
      <p:pic>
        <p:nvPicPr>
          <p:cNvPr id="35" name="Picture 4" descr="pPAZ1021008">
            <a:extLst>
              <a:ext uri="{FF2B5EF4-FFF2-40B4-BE49-F238E27FC236}">
                <a16:creationId xmlns:a16="http://schemas.microsoft.com/office/drawing/2014/main" id="{DD53504C-CDF1-4443-90D1-0AC7DA30F70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lum bright="6000" contrast="-1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5875" t="-4227" r="-3005" b="-218"/>
          <a:stretch/>
        </p:blipFill>
        <p:spPr bwMode="auto">
          <a:xfrm>
            <a:off x="6354147" y="0"/>
            <a:ext cx="5178490" cy="30324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Text Box 7">
            <a:extLst>
              <a:ext uri="{FF2B5EF4-FFF2-40B4-BE49-F238E27FC236}">
                <a16:creationId xmlns:a16="http://schemas.microsoft.com/office/drawing/2014/main" id="{052C37AC-B0A6-4757-B36D-B79C04E6FB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66989" y="905558"/>
            <a:ext cx="171527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1200" dirty="0"/>
              <a:t>DH5</a:t>
            </a:r>
            <a:r>
              <a:rPr lang="es-ES" altLang="es-ES" sz="1200" dirty="0">
                <a:latin typeface="Symbol" panose="05050102010706020507" pitchFamily="18" charset="2"/>
              </a:rPr>
              <a:t>a</a:t>
            </a:r>
            <a:r>
              <a:rPr lang="es-ES" altLang="es-ES" sz="1200" dirty="0"/>
              <a:t> (pPAZ1)- </a:t>
            </a:r>
            <a:r>
              <a:rPr lang="es-ES" altLang="es-ES" sz="1200" dirty="0" err="1"/>
              <a:t>PhaZKT</a:t>
            </a:r>
            <a:endParaRPr lang="es-ES" altLang="es-ES" sz="1200" dirty="0"/>
          </a:p>
        </p:txBody>
      </p:sp>
      <p:sp>
        <p:nvSpPr>
          <p:cNvPr id="37" name="Text Box 16">
            <a:extLst>
              <a:ext uri="{FF2B5EF4-FFF2-40B4-BE49-F238E27FC236}">
                <a16:creationId xmlns:a16="http://schemas.microsoft.com/office/drawing/2014/main" id="{BE5D7930-84B9-463C-B698-3BAC8941C7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84577" y="710780"/>
            <a:ext cx="36036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/>
              <a:t>1</a:t>
            </a:r>
          </a:p>
        </p:txBody>
      </p:sp>
      <p:sp>
        <p:nvSpPr>
          <p:cNvPr id="38" name="Text Box 17">
            <a:extLst>
              <a:ext uri="{FF2B5EF4-FFF2-40B4-BE49-F238E27FC236}">
                <a16:creationId xmlns:a16="http://schemas.microsoft.com/office/drawing/2014/main" id="{D5ED5BF5-DFC6-443F-9482-1112858303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41733" y="710780"/>
            <a:ext cx="36036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/>
              <a:t>2</a:t>
            </a:r>
          </a:p>
        </p:txBody>
      </p:sp>
      <p:sp>
        <p:nvSpPr>
          <p:cNvPr id="39" name="Text Box 18">
            <a:extLst>
              <a:ext uri="{FF2B5EF4-FFF2-40B4-BE49-F238E27FC236}">
                <a16:creationId xmlns:a16="http://schemas.microsoft.com/office/drawing/2014/main" id="{014192CC-4740-419B-AE76-9508D61066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47160" y="710780"/>
            <a:ext cx="36036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/>
              <a:t>3</a:t>
            </a:r>
          </a:p>
        </p:txBody>
      </p:sp>
      <p:sp>
        <p:nvSpPr>
          <p:cNvPr id="40" name="Text Box 19">
            <a:extLst>
              <a:ext uri="{FF2B5EF4-FFF2-40B4-BE49-F238E27FC236}">
                <a16:creationId xmlns:a16="http://schemas.microsoft.com/office/drawing/2014/main" id="{D7D9DE7C-4651-49F7-A3B1-40EC4FF86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71217" y="710780"/>
            <a:ext cx="360362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 dirty="0"/>
              <a:t>4</a:t>
            </a:r>
          </a:p>
        </p:txBody>
      </p:sp>
      <p:sp>
        <p:nvSpPr>
          <p:cNvPr id="22" name="Text Box 8">
            <a:extLst>
              <a:ext uri="{FF2B5EF4-FFF2-40B4-BE49-F238E27FC236}">
                <a16:creationId xmlns:a16="http://schemas.microsoft.com/office/drawing/2014/main" id="{16AF08C9-A901-4825-9CA2-E914ABFA35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55641" y="4167737"/>
            <a:ext cx="171527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1200" dirty="0"/>
              <a:t>DH10B (pUC32)- S184F</a:t>
            </a:r>
          </a:p>
        </p:txBody>
      </p:sp>
      <p:sp>
        <p:nvSpPr>
          <p:cNvPr id="26" name="Text Box 16">
            <a:extLst>
              <a:ext uri="{FF2B5EF4-FFF2-40B4-BE49-F238E27FC236}">
                <a16:creationId xmlns:a16="http://schemas.microsoft.com/office/drawing/2014/main" id="{B6A66E8D-1983-402D-9406-14EAD2C2EE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35907" y="4177101"/>
            <a:ext cx="36036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/>
              <a:t>1</a:t>
            </a:r>
          </a:p>
        </p:txBody>
      </p:sp>
      <p:sp>
        <p:nvSpPr>
          <p:cNvPr id="27" name="Text Box 17">
            <a:extLst>
              <a:ext uri="{FF2B5EF4-FFF2-40B4-BE49-F238E27FC236}">
                <a16:creationId xmlns:a16="http://schemas.microsoft.com/office/drawing/2014/main" id="{05FE12CA-3145-47C5-94A4-D5E779061D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67707" y="4177101"/>
            <a:ext cx="36036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/>
              <a:t>2</a:t>
            </a:r>
          </a:p>
        </p:txBody>
      </p:sp>
      <p:sp>
        <p:nvSpPr>
          <p:cNvPr id="28" name="Text Box 18">
            <a:extLst>
              <a:ext uri="{FF2B5EF4-FFF2-40B4-BE49-F238E27FC236}">
                <a16:creationId xmlns:a16="http://schemas.microsoft.com/office/drawing/2014/main" id="{2945DDE0-2CBE-47B7-B3C9-75523CD673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26482" y="4177101"/>
            <a:ext cx="36036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/>
              <a:t>3</a:t>
            </a:r>
          </a:p>
        </p:txBody>
      </p:sp>
      <p:sp>
        <p:nvSpPr>
          <p:cNvPr id="29" name="Text Box 19">
            <a:extLst>
              <a:ext uri="{FF2B5EF4-FFF2-40B4-BE49-F238E27FC236}">
                <a16:creationId xmlns:a16="http://schemas.microsoft.com/office/drawing/2014/main" id="{006E6D9B-9015-4D08-94F2-77086A5BB1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59869" y="4177101"/>
            <a:ext cx="360362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 dirty="0"/>
              <a:t>4</a:t>
            </a:r>
          </a:p>
        </p:txBody>
      </p:sp>
      <p:pic>
        <p:nvPicPr>
          <p:cNvPr id="44" name="Picture 6" descr="881021008">
            <a:extLst>
              <a:ext uri="{FF2B5EF4-FFF2-40B4-BE49-F238E27FC236}">
                <a16:creationId xmlns:a16="http://schemas.microsoft.com/office/drawing/2014/main" id="{F43D72C1-1E04-4CA5-8B9E-5F81DB4C71A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lum brigh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63" t="43481" r="18620" b="48386"/>
          <a:stretch>
            <a:fillRect/>
          </a:stretch>
        </p:blipFill>
        <p:spPr bwMode="auto">
          <a:xfrm>
            <a:off x="817856" y="1780073"/>
            <a:ext cx="1800225" cy="215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6" name="Picture 6" descr="881021008">
            <a:extLst>
              <a:ext uri="{FF2B5EF4-FFF2-40B4-BE49-F238E27FC236}">
                <a16:creationId xmlns:a16="http://schemas.microsoft.com/office/drawing/2014/main" id="{741AF986-1BF0-4CF6-966C-134F63CC511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lum brigh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628" t="-12677" r="-10771" b="-9991"/>
          <a:stretch/>
        </p:blipFill>
        <p:spPr bwMode="auto">
          <a:xfrm>
            <a:off x="6762467" y="3256383"/>
            <a:ext cx="4833257" cy="32563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7" name="Text Box 16">
            <a:extLst>
              <a:ext uri="{FF2B5EF4-FFF2-40B4-BE49-F238E27FC236}">
                <a16:creationId xmlns:a16="http://schemas.microsoft.com/office/drawing/2014/main" id="{B61CA2EA-B09C-4EB9-8E5C-648CBD8D9B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0210" y="650129"/>
            <a:ext cx="36036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/>
              <a:t>1</a:t>
            </a:r>
          </a:p>
        </p:txBody>
      </p:sp>
      <p:sp>
        <p:nvSpPr>
          <p:cNvPr id="48" name="Text Box 17">
            <a:extLst>
              <a:ext uri="{FF2B5EF4-FFF2-40B4-BE49-F238E27FC236}">
                <a16:creationId xmlns:a16="http://schemas.microsoft.com/office/drawing/2014/main" id="{8F0BC417-B11F-4353-AF86-24D8C122A5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32010" y="650129"/>
            <a:ext cx="36036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/>
              <a:t>2</a:t>
            </a:r>
          </a:p>
        </p:txBody>
      </p:sp>
      <p:sp>
        <p:nvSpPr>
          <p:cNvPr id="50" name="Text Box 18">
            <a:extLst>
              <a:ext uri="{FF2B5EF4-FFF2-40B4-BE49-F238E27FC236}">
                <a16:creationId xmlns:a16="http://schemas.microsoft.com/office/drawing/2014/main" id="{B1048060-F790-44EF-AD24-E653E977A1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0785" y="687451"/>
            <a:ext cx="36036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/>
              <a:t>3</a:t>
            </a:r>
          </a:p>
        </p:txBody>
      </p:sp>
      <p:sp>
        <p:nvSpPr>
          <p:cNvPr id="51" name="Text Box 19">
            <a:extLst>
              <a:ext uri="{FF2B5EF4-FFF2-40B4-BE49-F238E27FC236}">
                <a16:creationId xmlns:a16="http://schemas.microsoft.com/office/drawing/2014/main" id="{D1AE59BF-7B81-4B17-A2F8-57E23F3C3D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24172" y="687451"/>
            <a:ext cx="360362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 dirty="0"/>
              <a:t>4</a:t>
            </a:r>
          </a:p>
        </p:txBody>
      </p:sp>
      <p:sp>
        <p:nvSpPr>
          <p:cNvPr id="52" name="Text Box 8">
            <a:extLst>
              <a:ext uri="{FF2B5EF4-FFF2-40B4-BE49-F238E27FC236}">
                <a16:creationId xmlns:a16="http://schemas.microsoft.com/office/drawing/2014/main" id="{6A9967F6-9EF8-4329-9152-1B644CFE37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62540" y="1303239"/>
            <a:ext cx="171527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1200" dirty="0"/>
              <a:t>DH10B (pUC32)- S184F</a:t>
            </a:r>
          </a:p>
        </p:txBody>
      </p:sp>
      <p:sp>
        <p:nvSpPr>
          <p:cNvPr id="53" name="Text Box 9">
            <a:extLst>
              <a:ext uri="{FF2B5EF4-FFF2-40B4-BE49-F238E27FC236}">
                <a16:creationId xmlns:a16="http://schemas.microsoft.com/office/drawing/2014/main" id="{839A4C26-11B9-4804-8261-C1BB252A8AD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46102" y="4688471"/>
            <a:ext cx="184589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1200" dirty="0"/>
              <a:t>DH10B (pUC88)-  G286R</a:t>
            </a:r>
          </a:p>
        </p:txBody>
      </p:sp>
      <p:sp>
        <p:nvSpPr>
          <p:cNvPr id="54" name="Text Box 16">
            <a:extLst>
              <a:ext uri="{FF2B5EF4-FFF2-40B4-BE49-F238E27FC236}">
                <a16:creationId xmlns:a16="http://schemas.microsoft.com/office/drawing/2014/main" id="{7EB07B13-7514-4A7A-9AE2-2D3DDCB0A7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45028" y="4326390"/>
            <a:ext cx="36036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/>
              <a:t>1</a:t>
            </a:r>
          </a:p>
        </p:txBody>
      </p:sp>
      <p:sp>
        <p:nvSpPr>
          <p:cNvPr id="55" name="Text Box 17">
            <a:extLst>
              <a:ext uri="{FF2B5EF4-FFF2-40B4-BE49-F238E27FC236}">
                <a16:creationId xmlns:a16="http://schemas.microsoft.com/office/drawing/2014/main" id="{1C899FB0-3C63-4178-914A-29E25D5D13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76828" y="4326390"/>
            <a:ext cx="36036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/>
              <a:t>2</a:t>
            </a:r>
          </a:p>
        </p:txBody>
      </p:sp>
      <p:sp>
        <p:nvSpPr>
          <p:cNvPr id="56" name="Text Box 18">
            <a:extLst>
              <a:ext uri="{FF2B5EF4-FFF2-40B4-BE49-F238E27FC236}">
                <a16:creationId xmlns:a16="http://schemas.microsoft.com/office/drawing/2014/main" id="{324F88A5-C2B7-452B-8A16-A552005132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535603" y="4326390"/>
            <a:ext cx="360363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/>
              <a:t>3</a:t>
            </a:r>
          </a:p>
        </p:txBody>
      </p:sp>
      <p:sp>
        <p:nvSpPr>
          <p:cNvPr id="57" name="Text Box 19">
            <a:extLst>
              <a:ext uri="{FF2B5EF4-FFF2-40B4-BE49-F238E27FC236}">
                <a16:creationId xmlns:a16="http://schemas.microsoft.com/office/drawing/2014/main" id="{3614B2C4-E644-4885-A215-5DB4459EB9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68990" y="4326390"/>
            <a:ext cx="360362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altLang="es-ES" sz="900" dirty="0"/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38626021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>
            <a:extLst>
              <a:ext uri="{FF2B5EF4-FFF2-40B4-BE49-F238E27FC236}">
                <a16:creationId xmlns:a16="http://schemas.microsoft.com/office/drawing/2014/main" id="{C00811AD-8CF3-4CEB-9A31-D2C552C4944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74" t="34556" r="30319" b="43222"/>
          <a:stretch/>
        </p:blipFill>
        <p:spPr>
          <a:xfrm>
            <a:off x="6466115" y="1080131"/>
            <a:ext cx="5635690" cy="3398563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34EC7B01-31B8-41D4-8ED9-73665B006AD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8" t="-1318" r="2044" b="-3490"/>
          <a:stretch/>
        </p:blipFill>
        <p:spPr>
          <a:xfrm>
            <a:off x="223935" y="802432"/>
            <a:ext cx="6055567" cy="4320073"/>
          </a:xfrm>
          <a:prstGeom prst="rect">
            <a:avLst/>
          </a:prstGeom>
        </p:spPr>
      </p:pic>
      <p:sp>
        <p:nvSpPr>
          <p:cNvPr id="16" name="Rectángulo 15">
            <a:extLst>
              <a:ext uri="{FF2B5EF4-FFF2-40B4-BE49-F238E27FC236}">
                <a16:creationId xmlns:a16="http://schemas.microsoft.com/office/drawing/2014/main" id="{C403AEB5-42E3-4C8E-A57D-7D7C51D015ED}"/>
              </a:ext>
            </a:extLst>
          </p:cNvPr>
          <p:cNvSpPr/>
          <p:nvPr/>
        </p:nvSpPr>
        <p:spPr>
          <a:xfrm>
            <a:off x="440561" y="5393069"/>
            <a:ext cx="904245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Uncropped version of Figure S1.</a:t>
            </a:r>
            <a:endParaRPr lang="es-ES" sz="1200" dirty="0"/>
          </a:p>
        </p:txBody>
      </p:sp>
      <p:cxnSp>
        <p:nvCxnSpPr>
          <p:cNvPr id="18" name="Conector recto de flecha 17">
            <a:extLst>
              <a:ext uri="{FF2B5EF4-FFF2-40B4-BE49-F238E27FC236}">
                <a16:creationId xmlns:a16="http://schemas.microsoft.com/office/drawing/2014/main" id="{FB74F7B4-B2D9-4AAA-AB8C-4C37DDC7B878}"/>
              </a:ext>
            </a:extLst>
          </p:cNvPr>
          <p:cNvCxnSpPr>
            <a:cxnSpLocks/>
          </p:cNvCxnSpPr>
          <p:nvPr/>
        </p:nvCxnSpPr>
        <p:spPr>
          <a:xfrm flipH="1">
            <a:off x="5174863" y="2917889"/>
            <a:ext cx="330199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Google Shape;588;p21">
            <a:extLst>
              <a:ext uri="{FF2B5EF4-FFF2-40B4-BE49-F238E27FC236}">
                <a16:creationId xmlns:a16="http://schemas.microsoft.com/office/drawing/2014/main" id="{7C6DFF34-422E-4637-8A39-61148889B4C3}"/>
              </a:ext>
            </a:extLst>
          </p:cNvPr>
          <p:cNvSpPr txBox="1"/>
          <p:nvPr/>
        </p:nvSpPr>
        <p:spPr>
          <a:xfrm>
            <a:off x="1186925" y="718110"/>
            <a:ext cx="31582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" name="Google Shape;588;p21">
            <a:extLst>
              <a:ext uri="{FF2B5EF4-FFF2-40B4-BE49-F238E27FC236}">
                <a16:creationId xmlns:a16="http://schemas.microsoft.com/office/drawing/2014/main" id="{C5C28800-F285-42FF-BE0F-A8EC41C4F3C8}"/>
              </a:ext>
            </a:extLst>
          </p:cNvPr>
          <p:cNvSpPr txBox="1"/>
          <p:nvPr/>
        </p:nvSpPr>
        <p:spPr>
          <a:xfrm>
            <a:off x="1724558" y="718110"/>
            <a:ext cx="31582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7" name="Google Shape;588;p21">
            <a:extLst>
              <a:ext uri="{FF2B5EF4-FFF2-40B4-BE49-F238E27FC236}">
                <a16:creationId xmlns:a16="http://schemas.microsoft.com/office/drawing/2014/main" id="{D092822B-37E9-4049-AEB3-032AEB180182}"/>
              </a:ext>
            </a:extLst>
          </p:cNvPr>
          <p:cNvSpPr txBox="1"/>
          <p:nvPr/>
        </p:nvSpPr>
        <p:spPr>
          <a:xfrm>
            <a:off x="2262191" y="718110"/>
            <a:ext cx="31582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" name="Google Shape;588;p21">
            <a:extLst>
              <a:ext uri="{FF2B5EF4-FFF2-40B4-BE49-F238E27FC236}">
                <a16:creationId xmlns:a16="http://schemas.microsoft.com/office/drawing/2014/main" id="{B95925BC-67C3-4F7A-902E-1FF66601A60D}"/>
              </a:ext>
            </a:extLst>
          </p:cNvPr>
          <p:cNvSpPr txBox="1"/>
          <p:nvPr/>
        </p:nvSpPr>
        <p:spPr>
          <a:xfrm>
            <a:off x="2825224" y="718110"/>
            <a:ext cx="31582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" name="Google Shape;588;p21">
            <a:extLst>
              <a:ext uri="{FF2B5EF4-FFF2-40B4-BE49-F238E27FC236}">
                <a16:creationId xmlns:a16="http://schemas.microsoft.com/office/drawing/2014/main" id="{0F8BF64A-A1D3-4619-B0B1-94E9618E0799}"/>
              </a:ext>
            </a:extLst>
          </p:cNvPr>
          <p:cNvSpPr txBox="1"/>
          <p:nvPr/>
        </p:nvSpPr>
        <p:spPr>
          <a:xfrm>
            <a:off x="3362857" y="718110"/>
            <a:ext cx="31582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" name="Google Shape;588;p21">
            <a:extLst>
              <a:ext uri="{FF2B5EF4-FFF2-40B4-BE49-F238E27FC236}">
                <a16:creationId xmlns:a16="http://schemas.microsoft.com/office/drawing/2014/main" id="{AE962007-100A-43DD-B293-3FE38C9F5008}"/>
              </a:ext>
            </a:extLst>
          </p:cNvPr>
          <p:cNvSpPr txBox="1"/>
          <p:nvPr/>
        </p:nvSpPr>
        <p:spPr>
          <a:xfrm>
            <a:off x="3951290" y="718110"/>
            <a:ext cx="31582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" name="Google Shape;588;p21">
            <a:extLst>
              <a:ext uri="{FF2B5EF4-FFF2-40B4-BE49-F238E27FC236}">
                <a16:creationId xmlns:a16="http://schemas.microsoft.com/office/drawing/2014/main" id="{47161941-7149-4DBA-8C89-56B0A8F8979B}"/>
              </a:ext>
            </a:extLst>
          </p:cNvPr>
          <p:cNvSpPr txBox="1"/>
          <p:nvPr/>
        </p:nvSpPr>
        <p:spPr>
          <a:xfrm>
            <a:off x="4539723" y="718110"/>
            <a:ext cx="31582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7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" name="Google Shape;588;p21">
            <a:extLst>
              <a:ext uri="{FF2B5EF4-FFF2-40B4-BE49-F238E27FC236}">
                <a16:creationId xmlns:a16="http://schemas.microsoft.com/office/drawing/2014/main" id="{18684DEF-FE8B-46AE-8B09-7D0CFE7C6A40}"/>
              </a:ext>
            </a:extLst>
          </p:cNvPr>
          <p:cNvSpPr txBox="1"/>
          <p:nvPr/>
        </p:nvSpPr>
        <p:spPr>
          <a:xfrm>
            <a:off x="9619809" y="1175569"/>
            <a:ext cx="31582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" name="Google Shape;588;p21">
            <a:extLst>
              <a:ext uri="{FF2B5EF4-FFF2-40B4-BE49-F238E27FC236}">
                <a16:creationId xmlns:a16="http://schemas.microsoft.com/office/drawing/2014/main" id="{AD3077D1-8BB9-4F82-9697-C1358852D437}"/>
              </a:ext>
            </a:extLst>
          </p:cNvPr>
          <p:cNvSpPr txBox="1"/>
          <p:nvPr/>
        </p:nvSpPr>
        <p:spPr>
          <a:xfrm>
            <a:off x="10157442" y="1175569"/>
            <a:ext cx="31582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2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5" name="Google Shape;588;p21">
            <a:extLst>
              <a:ext uri="{FF2B5EF4-FFF2-40B4-BE49-F238E27FC236}">
                <a16:creationId xmlns:a16="http://schemas.microsoft.com/office/drawing/2014/main" id="{00D5BF62-F383-43A2-B70B-6882B66684B8}"/>
              </a:ext>
            </a:extLst>
          </p:cNvPr>
          <p:cNvSpPr txBox="1"/>
          <p:nvPr/>
        </p:nvSpPr>
        <p:spPr>
          <a:xfrm>
            <a:off x="10720478" y="1175569"/>
            <a:ext cx="31582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3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6" name="Google Shape;588;p21">
            <a:extLst>
              <a:ext uri="{FF2B5EF4-FFF2-40B4-BE49-F238E27FC236}">
                <a16:creationId xmlns:a16="http://schemas.microsoft.com/office/drawing/2014/main" id="{AC744DA1-8195-4E95-BD8D-182FB19F4AE8}"/>
              </a:ext>
            </a:extLst>
          </p:cNvPr>
          <p:cNvSpPr txBox="1"/>
          <p:nvPr/>
        </p:nvSpPr>
        <p:spPr>
          <a:xfrm>
            <a:off x="564625" y="464110"/>
            <a:ext cx="31582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7" name="Google Shape;588;p21">
            <a:extLst>
              <a:ext uri="{FF2B5EF4-FFF2-40B4-BE49-F238E27FC236}">
                <a16:creationId xmlns:a16="http://schemas.microsoft.com/office/drawing/2014/main" id="{01B4CCE3-B603-4FAD-8A84-9F17768F81C2}"/>
              </a:ext>
            </a:extLst>
          </p:cNvPr>
          <p:cNvSpPr txBox="1"/>
          <p:nvPr/>
        </p:nvSpPr>
        <p:spPr>
          <a:xfrm>
            <a:off x="6616305" y="697634"/>
            <a:ext cx="315823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s-E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6896580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58</Words>
  <Application>Microsoft Office PowerPoint</Application>
  <PresentationFormat>Panorámica</PresentationFormat>
  <Paragraphs>55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10" baseType="lpstr">
      <vt:lpstr>MS Mincho</vt:lpstr>
      <vt:lpstr>Arial</vt:lpstr>
      <vt:lpstr>Calibri</vt:lpstr>
      <vt:lpstr>Calibri Light</vt:lpstr>
      <vt:lpstr>Symbol</vt:lpstr>
      <vt:lpstr>Times New Roman</vt:lpstr>
      <vt:lpstr>Tema de Offic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idem</dc:creator>
  <cp:lastModifiedBy>lidem</cp:lastModifiedBy>
  <cp:revision>2</cp:revision>
  <dcterms:created xsi:type="dcterms:W3CDTF">2025-07-24T07:36:31Z</dcterms:created>
  <dcterms:modified xsi:type="dcterms:W3CDTF">2025-07-24T07:43:35Z</dcterms:modified>
</cp:coreProperties>
</file>